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7B57AE6-7747-412F-94BE-E5A98E1B7DC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CAF637-6D0E-43BC-8C0E-717FA53D232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D781CD-238F-4014-9CCE-86DCA876FEB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B8F0C9-F58B-4470-9A5F-E8B451F4B23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0D1EBD-FD99-45D5-B688-20EDBBF6FE1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4AEAD9-F05E-46C6-A066-C11DEE2BE77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A85D28-9CCE-4987-938A-0FC90838D38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09A75F-D526-4DC1-B100-D0D069BFB9F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74460E-CD65-4CAC-8499-BCAB3B5C090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6F36FE-C3F3-47F0-B122-870CD70EDBD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96C035-C5E8-4FC1-9EA6-630077841C0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51B48F-D37D-4B4D-A615-319DB1BF706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5122C8DB-4F11-461F-9A62-773AE4B6A456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2"/>
          <p:cNvSpPr/>
          <p:nvPr/>
        </p:nvSpPr>
        <p:spPr>
          <a:xfrm>
            <a:off x="2520" y="46080"/>
            <a:ext cx="2326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Malgun Gothic"/>
              </a:rPr>
              <a:t>Supplementary Table 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4703760" y="1057320"/>
          <a:ext cx="4070520" cy="4417920"/>
        </p:xfrm>
        <a:graphic>
          <a:graphicData uri="http://schemas.openxmlformats.org/drawingml/2006/table">
            <a:tbl>
              <a:tblPr/>
              <a:tblGrid>
                <a:gridCol w="855720"/>
                <a:gridCol w="685800"/>
                <a:gridCol w="785880"/>
                <a:gridCol w="1390680"/>
                <a:gridCol w="352440"/>
              </a:tblGrid>
              <a:tr h="19188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nimal model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ell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pleen (S)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umor(T)%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/S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224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/+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ontrol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6.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7.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4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9224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9.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5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188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5.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2.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6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224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4.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6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188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.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7.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4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224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0.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5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188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iRZIP15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4.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4.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9224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7.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7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224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1.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9.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9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188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7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224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8.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4.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6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188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6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224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/KO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ontrol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4.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1.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3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9224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1.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2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188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6.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8.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0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224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6.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9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188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4.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3.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9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224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2.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9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9188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iRZIP15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1.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7.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8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9224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4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224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0.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9.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8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1880"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0" rIns="0" tIns="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7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43" name=""/>
          <p:cNvGraphicFramePr/>
          <p:nvPr/>
        </p:nvGraphicFramePr>
        <p:xfrm>
          <a:off x="338040" y="1057320"/>
          <a:ext cx="4216320" cy="4444920"/>
        </p:xfrm>
        <a:graphic>
          <a:graphicData uri="http://schemas.openxmlformats.org/drawingml/2006/table">
            <a:tbl>
              <a:tblPr/>
              <a:tblGrid>
                <a:gridCol w="887400"/>
                <a:gridCol w="709560"/>
                <a:gridCol w="814680"/>
                <a:gridCol w="1439640"/>
                <a:gridCol w="365040"/>
              </a:tblGrid>
              <a:tr h="17784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nimal mode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ell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Spleen (S)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umor (T)%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T/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784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/+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ontro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.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.0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7784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3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.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748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7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8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784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9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9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784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.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.7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784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4.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.6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784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iRZIP15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0.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5.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.3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7784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6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.4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784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.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8.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.7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784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.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784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8.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.7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748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.6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784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KO/KO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Control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9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6.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.9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7784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6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.9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784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5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.9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784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3.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.6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784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2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.2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784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2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5.2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7784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miRZIP15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.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1.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.0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7784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44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.4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748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3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6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.6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7840"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6.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7.5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7840"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.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21.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8.0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7840"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457200"/>
                          <a:tab algn="l" pos="914400"/>
                          <a:tab algn="l" pos="1371600"/>
                          <a:tab algn="l" pos="1828800"/>
                          <a:tab algn="l" pos="2286000"/>
                          <a:tab algn="l" pos="2743200"/>
                          <a:tab algn="l" pos="3200400"/>
                          <a:tab algn="l" pos="3657600"/>
                          <a:tab algn="l" pos="4114800"/>
                          <a:tab algn="l" pos="4572000"/>
                          <a:tab algn="l" pos="5029200"/>
                          <a:tab algn="l" pos="5486400"/>
                          <a:tab algn="l" pos="5943600"/>
                          <a:tab algn="l" pos="6400800"/>
                          <a:tab algn="l" pos="6858000"/>
                          <a:tab algn="l" pos="7315200"/>
                          <a:tab algn="l" pos="7772400"/>
                          <a:tab algn="l" pos="8229600"/>
                          <a:tab algn="l" pos="8686800"/>
                          <a:tab algn="l" pos="91440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6.6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4" name="TextBox 4"/>
          <p:cNvSpPr/>
          <p:nvPr/>
        </p:nvSpPr>
        <p:spPr>
          <a:xfrm>
            <a:off x="261000" y="5486400"/>
            <a:ext cx="422100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Malgun Gothic"/>
              </a:rPr>
              <a:t>Numbers indicate portion of MDSC either in spleen (S) or in Tumor (T).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Malgun Gothic"/>
              </a:rPr>
              <a:t>The final column T/S shows</a:t>
            </a:r>
            <a:r>
              <a:rPr b="0" lang="ko-KR" sz="1100" spc="-1" strike="noStrike">
                <a:solidFill>
                  <a:srgbClr val="000000"/>
                </a:solidFill>
                <a:latin typeface="Calibri"/>
                <a:ea typeface="Malgun Gothic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Malgun Gothic"/>
              </a:rPr>
              <a:t>the ratio of tumor MDSC relative to spleen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5"/>
          <p:cNvSpPr/>
          <p:nvPr/>
        </p:nvSpPr>
        <p:spPr>
          <a:xfrm>
            <a:off x="4744800" y="5486400"/>
            <a:ext cx="4221000" cy="428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Malgun Gothic"/>
              </a:rPr>
              <a:t>Numbers indicate portion of MDSC either in spleen (S) or in Tumor (T). 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Malgun Gothic"/>
              </a:rPr>
              <a:t>The final column T/S shows</a:t>
            </a:r>
            <a:r>
              <a:rPr b="0" lang="ko-KR" sz="1100" spc="-1" strike="noStrike">
                <a:solidFill>
                  <a:srgbClr val="000000"/>
                </a:solidFill>
                <a:latin typeface="Calibri"/>
                <a:ea typeface="Malgun Gothic"/>
              </a:rPr>
              <a:t> </a:t>
            </a:r>
            <a:r>
              <a:rPr b="0" lang="en-US" sz="1100" spc="-1" strike="noStrike">
                <a:solidFill>
                  <a:srgbClr val="000000"/>
                </a:solidFill>
                <a:latin typeface="Calibri"/>
                <a:ea typeface="Malgun Gothic"/>
              </a:rPr>
              <a:t>the ratio of tumor MDSC relative to spleen</a:t>
            </a:r>
            <a:endParaRPr b="0" lang="en-US" sz="11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46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7-12T13:24:58Z</dcterms:created>
  <dc:creator>Mac User</dc:creator>
  <dc:description/>
  <dc:language>en-US</dc:language>
  <cp:lastModifiedBy>Kishorekumar Kubendran</cp:lastModifiedBy>
  <cp:lastPrinted>2011-12-05T14:53:12Z</cp:lastPrinted>
  <dcterms:modified xsi:type="dcterms:W3CDTF">2016-01-23T07:12:10Z</dcterms:modified>
  <cp:revision>1283</cp:revision>
  <dc:subject/>
  <dc:title>Slide 1</dc:title>
</cp:coreProperties>
</file>